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3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0">
            <a:extLst>
              <a:ext uri="{FF2B5EF4-FFF2-40B4-BE49-F238E27FC236}">
                <a16:creationId xmlns:a16="http://schemas.microsoft.com/office/drawing/2014/main" id="{21C0FC23-9705-4695-D512-5F373036EE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774" y="1527858"/>
            <a:ext cx="10123426" cy="3032567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9C130A60-0699-7E21-04C6-5F6970593068}"/>
              </a:ext>
            </a:extLst>
          </p:cNvPr>
          <p:cNvSpPr txBox="1"/>
          <p:nvPr/>
        </p:nvSpPr>
        <p:spPr>
          <a:xfrm>
            <a:off x="2279007" y="438271"/>
            <a:ext cx="61899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Genomic sequencing showing overlaps at SNPs and Indels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52EDBCE-3860-DB34-F4E4-3E1F233EC029}"/>
              </a:ext>
            </a:extLst>
          </p:cNvPr>
          <p:cNvSpPr txBox="1"/>
          <p:nvPr/>
        </p:nvSpPr>
        <p:spPr>
          <a:xfrm>
            <a:off x="3185903" y="4952743"/>
            <a:ext cx="513686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dirty="0"/>
              <a:t>Supplementary figure 10. Synonymous exome SNPs and Indel sequences of ME180 and GAN edited clones</a:t>
            </a:r>
          </a:p>
        </p:txBody>
      </p:sp>
    </p:spTree>
    <p:extLst>
      <p:ext uri="{BB962C8B-B14F-4D97-AF65-F5344CB8AC3E}">
        <p14:creationId xmlns:p14="http://schemas.microsoft.com/office/powerpoint/2010/main" val="186550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24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9</cp:revision>
  <dcterms:created xsi:type="dcterms:W3CDTF">2024-02-09T21:19:49Z</dcterms:created>
  <dcterms:modified xsi:type="dcterms:W3CDTF">2024-02-09T21:51:49Z</dcterms:modified>
</cp:coreProperties>
</file>